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8CBF19-737C-22DA-7D58-382A7BE4DA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8298CA-A5EA-91FE-6F00-FF090B49D7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F10594-E60E-7528-8ED5-F6ED04942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9C7151-737E-1820-8735-F9B983D0E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BFB46-E5A6-C91F-24A2-19A73213D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8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7C883-7544-CF5C-B77A-9013EA56B3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60E3DB-4B6E-23B2-655D-0E8514131F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7AA7E1-7978-781C-9DF7-68B564AAF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4C1A8-43BE-0DF7-0FEF-8719DEE80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2506A-228A-C305-6312-8C3616095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35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A6F9A4-9804-8503-9577-3F461DD5D6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CA209F-06D3-0B79-8E18-2843252B4D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C4018F-6F0F-706E-E5AF-C6FD4F9DA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26E828-2EEC-5DE9-B337-948520AAE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B5E6A1-19D0-9733-E41F-E537A16EE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38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F1D4B8-0117-A6F1-3E85-8117F1D393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79B130-67E3-35FB-FB24-D2385B1E2D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969699-E7F9-0C52-7B9D-D91F8829E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9256C0-35CF-3DC1-F5FE-C076A5897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92526E-6BE0-84C6-9798-B6D98B383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347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E61EB-8D73-DEFF-3629-BA4F34F64F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3A8E9C-2878-0024-2057-19E243D127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621AA6-4595-2311-80F1-F6264916E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B8B07-6B28-ABBE-F8CD-371C993C2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AEE231-082B-B4EF-E0E4-273F65921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861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1B620-6AB1-2BC8-184F-FEAB76326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9586EE-0FD7-B68C-4E66-1837B0CFA4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EFD410-5D47-D829-3C3F-82A2625E4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422D30-8E2C-D33F-C07E-78702C6DE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A270C4-CD51-57A7-270E-784F79A18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224344-509C-9B30-2606-086228C6B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323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CF160-E798-7544-BF27-B864490A0E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7597A1-D8F5-49D7-262D-3ED6E3CE1F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6AF1E5-62B2-FCC8-CADF-852018A0CC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CAE1E9-833D-A257-4DA3-538B3DD6BE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C8E36E4-45D7-2D2E-D2D5-54D095E162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A5242D-E775-E83A-33AD-5D06D8DAC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095EAE-4FB4-6B66-AEC0-5A7997B78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1D7AAA-AB9C-38AD-69E2-FBD4F4879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509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ED117-C607-4C47-4C0B-07673146EC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68F4B3-0D13-DF11-46B1-5C78B017F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3D19AE-98E2-9A27-70B0-0CD145ECD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995B87-0426-AE42-BBE9-E98EE9BA5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488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4169C6-CE39-41FD-679F-E3F229C71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B0D05F-FC56-B4EE-8018-75EE34443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E687DE-1CC6-4F11-21BF-F109D1F76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959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5DA56-991F-471B-D6BA-05D3E45F68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692B4-5CDB-38F6-345A-C210EE5DB9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9450C8-6D8C-AC33-A39A-D6705E1366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9D04B5-C687-BC7C-0B85-539422C4C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002927-5012-5A8A-9F49-72AE31133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F15D33-4BFC-CED4-E02E-072C777E7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354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545C82-898B-739A-D3CA-AA46831BB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66F7D5-96F5-A444-8F84-5F45A66D70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D80EC4-50E3-152B-4E8C-C3D24C6307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0F4690-D40B-EC89-5551-A96E79EB6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5CA05A-9DB5-00B3-3226-1A0CAFC75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CAD800-27A6-0334-AD07-349A22BC4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2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29AD2B-B2EB-9B83-0E2F-67DB0DAAAF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07B0F6-881C-BDFB-53F9-8598B5CA19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BB15D6-209E-A614-139E-B571162C32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009AF-C355-C147-9F66-07753EAE667A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CEDA27-AE4F-5106-7AD7-83EFAE68B8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86E2CF-860C-A053-AE57-D8D210B5E7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D30B1F-E4E8-8740-BF7E-0A6038EB9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551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993F8EBA-61DC-5696-9FC2-BE6F6FEFF64F}"/>
              </a:ext>
            </a:extLst>
          </p:cNvPr>
          <p:cNvSpPr txBox="1"/>
          <p:nvPr/>
        </p:nvSpPr>
        <p:spPr>
          <a:xfrm>
            <a:off x="4425274" y="48976"/>
            <a:ext cx="2894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Histones vs Beta Blockers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0400917-1C90-67B0-2343-3C8C72BDC85D}"/>
              </a:ext>
            </a:extLst>
          </p:cNvPr>
          <p:cNvGrpSpPr/>
          <p:nvPr/>
        </p:nvGrpSpPr>
        <p:grpSpPr>
          <a:xfrm>
            <a:off x="1808760" y="3782863"/>
            <a:ext cx="8386963" cy="369538"/>
            <a:chOff x="1710999" y="6118043"/>
            <a:chExt cx="8386963" cy="36953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ECA3B3D-6D88-3D34-0E3C-EF9F971C335B}"/>
                </a:ext>
              </a:extLst>
            </p:cNvPr>
            <p:cNvSpPr txBox="1"/>
            <p:nvPr/>
          </p:nvSpPr>
          <p:spPr>
            <a:xfrm>
              <a:off x="1710999" y="6118043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4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710A43D-7895-9625-59B1-C4678536FED5}"/>
                </a:ext>
              </a:extLst>
            </p:cNvPr>
            <p:cNvSpPr txBox="1"/>
            <p:nvPr/>
          </p:nvSpPr>
          <p:spPr>
            <a:xfrm>
              <a:off x="5302596" y="6118043"/>
              <a:ext cx="7088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/H4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33AFFA8-CD66-E7EE-346A-95A184C3F035}"/>
                </a:ext>
              </a:extLst>
            </p:cNvPr>
            <p:cNvSpPr txBox="1"/>
            <p:nvPr/>
          </p:nvSpPr>
          <p:spPr>
            <a:xfrm>
              <a:off x="8967909" y="6179804"/>
              <a:ext cx="11300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MacroH2A1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F5F0FE22-63F2-1B8C-6D6D-9A389EA57961}"/>
              </a:ext>
            </a:extLst>
          </p:cNvPr>
          <p:cNvGrpSpPr/>
          <p:nvPr/>
        </p:nvGrpSpPr>
        <p:grpSpPr>
          <a:xfrm>
            <a:off x="1775222" y="969802"/>
            <a:ext cx="8093650" cy="356640"/>
            <a:chOff x="1489912" y="746623"/>
            <a:chExt cx="8093650" cy="356640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7FE5439-4568-CCE2-B81D-55B3A35958A5}"/>
                </a:ext>
              </a:extLst>
            </p:cNvPr>
            <p:cNvSpPr txBox="1"/>
            <p:nvPr/>
          </p:nvSpPr>
          <p:spPr>
            <a:xfrm>
              <a:off x="1489912" y="795486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1B5B62D-3B9A-B386-162C-7360696B54CE}"/>
                </a:ext>
              </a:extLst>
            </p:cNvPr>
            <p:cNvSpPr txBox="1"/>
            <p:nvPr/>
          </p:nvSpPr>
          <p:spPr>
            <a:xfrm>
              <a:off x="5113648" y="746623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75C7E97-7126-2C95-A4FD-85CBE1273EA6}"/>
                </a:ext>
              </a:extLst>
            </p:cNvPr>
            <p:cNvSpPr txBox="1"/>
            <p:nvPr/>
          </p:nvSpPr>
          <p:spPr>
            <a:xfrm>
              <a:off x="9171270" y="762311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5750BE9-594B-CB19-CCAB-8E991997D273}"/>
              </a:ext>
            </a:extLst>
          </p:cNvPr>
          <p:cNvSpPr txBox="1"/>
          <p:nvPr/>
        </p:nvSpPr>
        <p:spPr>
          <a:xfrm>
            <a:off x="899170" y="331388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B23130-664E-9734-33D7-08B3D40C660D}"/>
              </a:ext>
            </a:extLst>
          </p:cNvPr>
          <p:cNvSpPr txBox="1"/>
          <p:nvPr/>
        </p:nvSpPr>
        <p:spPr>
          <a:xfrm>
            <a:off x="2447700" y="3325768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095192C-1757-9CA4-1E2B-36E9DB46E7F1}"/>
              </a:ext>
            </a:extLst>
          </p:cNvPr>
          <p:cNvSpPr txBox="1"/>
          <p:nvPr/>
        </p:nvSpPr>
        <p:spPr>
          <a:xfrm>
            <a:off x="1697352" y="3337919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C2CF87D-FAC1-FF51-5459-A691E3EE7E83}"/>
              </a:ext>
            </a:extLst>
          </p:cNvPr>
          <p:cNvSpPr txBox="1"/>
          <p:nvPr/>
        </p:nvSpPr>
        <p:spPr>
          <a:xfrm rot="16200000">
            <a:off x="234780" y="2353919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FE6A58C-7D43-BA22-2743-0F481E9FE83B}"/>
              </a:ext>
            </a:extLst>
          </p:cNvPr>
          <p:cNvSpPr txBox="1"/>
          <p:nvPr/>
        </p:nvSpPr>
        <p:spPr>
          <a:xfrm>
            <a:off x="2930364" y="847455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1306FB-A082-4F65-2EFE-2D7DFE4DC533}"/>
              </a:ext>
            </a:extLst>
          </p:cNvPr>
          <p:cNvSpPr txBox="1"/>
          <p:nvPr/>
        </p:nvSpPr>
        <p:spPr>
          <a:xfrm>
            <a:off x="2930364" y="980105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1A2C598-A2BB-2BA3-A223-F5F1A75EF338}"/>
              </a:ext>
            </a:extLst>
          </p:cNvPr>
          <p:cNvSpPr/>
          <p:nvPr/>
        </p:nvSpPr>
        <p:spPr>
          <a:xfrm>
            <a:off x="2840516" y="933670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6F1C6F5-F23C-1616-49C6-520C1D80E2F1}"/>
              </a:ext>
            </a:extLst>
          </p:cNvPr>
          <p:cNvSpPr/>
          <p:nvPr/>
        </p:nvSpPr>
        <p:spPr>
          <a:xfrm>
            <a:off x="2840516" y="1070164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4E9C9B5-63DA-19A5-08AC-51DA0586E254}"/>
              </a:ext>
            </a:extLst>
          </p:cNvPr>
          <p:cNvSpPr/>
          <p:nvPr/>
        </p:nvSpPr>
        <p:spPr>
          <a:xfrm>
            <a:off x="2840516" y="1205087"/>
            <a:ext cx="131348" cy="50824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7D72544-F4C0-AD11-9E70-E9C019A1A336}"/>
              </a:ext>
            </a:extLst>
          </p:cNvPr>
          <p:cNvSpPr txBox="1"/>
          <p:nvPr/>
        </p:nvSpPr>
        <p:spPr>
          <a:xfrm>
            <a:off x="2923952" y="112398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</a:p>
        </p:txBody>
      </p:sp>
      <p:pic>
        <p:nvPicPr>
          <p:cNvPr id="28" name="Content Placeholder 5">
            <a:extLst>
              <a:ext uri="{FF2B5EF4-FFF2-40B4-BE49-F238E27FC236}">
                <a16:creationId xmlns:a16="http://schemas.microsoft.com/office/drawing/2014/main" id="{A30070FD-0B6C-2160-17E2-4BF9D17F312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7" r="12600" b="8168"/>
          <a:stretch/>
        </p:blipFill>
        <p:spPr>
          <a:xfrm>
            <a:off x="547526" y="1376977"/>
            <a:ext cx="3056965" cy="193690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0C91C25-6231-75FC-69EE-BC3127C57C6D}"/>
              </a:ext>
            </a:extLst>
          </p:cNvPr>
          <p:cNvSpPr txBox="1"/>
          <p:nvPr/>
        </p:nvSpPr>
        <p:spPr>
          <a:xfrm>
            <a:off x="4470042" y="329759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4B03D69-187F-7549-802F-16015B21DF83}"/>
              </a:ext>
            </a:extLst>
          </p:cNvPr>
          <p:cNvSpPr txBox="1"/>
          <p:nvPr/>
        </p:nvSpPr>
        <p:spPr>
          <a:xfrm>
            <a:off x="6096000" y="3321199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DF57949-725A-8EF1-DCAE-F99B0A683CEC}"/>
              </a:ext>
            </a:extLst>
          </p:cNvPr>
          <p:cNvSpPr txBox="1"/>
          <p:nvPr/>
        </p:nvSpPr>
        <p:spPr>
          <a:xfrm>
            <a:off x="5351979" y="3334888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8078CAC-11ED-1F69-6FF2-0F2DD0CBC459}"/>
              </a:ext>
            </a:extLst>
          </p:cNvPr>
          <p:cNvSpPr txBox="1"/>
          <p:nvPr/>
        </p:nvSpPr>
        <p:spPr>
          <a:xfrm>
            <a:off x="6705060" y="817584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5CD7C10-220A-C222-40A4-29611C2C4F3B}"/>
              </a:ext>
            </a:extLst>
          </p:cNvPr>
          <p:cNvSpPr txBox="1"/>
          <p:nvPr/>
        </p:nvSpPr>
        <p:spPr>
          <a:xfrm>
            <a:off x="6705060" y="950234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D9F619C-4916-6A93-3965-B37F2D651F6B}"/>
              </a:ext>
            </a:extLst>
          </p:cNvPr>
          <p:cNvSpPr/>
          <p:nvPr/>
        </p:nvSpPr>
        <p:spPr>
          <a:xfrm>
            <a:off x="6615212" y="903799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989E196-BD8E-E1EE-24DC-8CCB9D48B3EA}"/>
              </a:ext>
            </a:extLst>
          </p:cNvPr>
          <p:cNvSpPr/>
          <p:nvPr/>
        </p:nvSpPr>
        <p:spPr>
          <a:xfrm>
            <a:off x="6615212" y="1040293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F3DA609-1342-8F1B-4A0E-FB3611DF4093}"/>
              </a:ext>
            </a:extLst>
          </p:cNvPr>
          <p:cNvSpPr/>
          <p:nvPr/>
        </p:nvSpPr>
        <p:spPr>
          <a:xfrm>
            <a:off x="6615212" y="1175216"/>
            <a:ext cx="131348" cy="50824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8A2324D-6DD8-D182-78E6-E9B6462DAB07}"/>
              </a:ext>
            </a:extLst>
          </p:cNvPr>
          <p:cNvSpPr txBox="1"/>
          <p:nvPr/>
        </p:nvSpPr>
        <p:spPr>
          <a:xfrm>
            <a:off x="6722694" y="108591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F1C1A69-D738-4F35-A5FF-1043E5C7FFDE}"/>
              </a:ext>
            </a:extLst>
          </p:cNvPr>
          <p:cNvSpPr txBox="1"/>
          <p:nvPr/>
        </p:nvSpPr>
        <p:spPr>
          <a:xfrm rot="16200000">
            <a:off x="3768333" y="2354720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  <a:endParaRPr lang="en-US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79BFCFD-D240-CF32-2952-35F247546C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5" r="12977" b="7473"/>
          <a:stretch/>
        </p:blipFill>
        <p:spPr>
          <a:xfrm>
            <a:off x="4073344" y="1335211"/>
            <a:ext cx="3243624" cy="1986415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2D85A27-E986-F866-ED13-C70C1766791D}"/>
              </a:ext>
            </a:extLst>
          </p:cNvPr>
          <p:cNvSpPr txBox="1"/>
          <p:nvPr/>
        </p:nvSpPr>
        <p:spPr>
          <a:xfrm>
            <a:off x="8488008" y="330929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2CFDE25-EA09-97F8-2779-F88837BC8E55}"/>
              </a:ext>
            </a:extLst>
          </p:cNvPr>
          <p:cNvSpPr txBox="1"/>
          <p:nvPr/>
        </p:nvSpPr>
        <p:spPr>
          <a:xfrm>
            <a:off x="10036538" y="3321181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9DDC70D-0910-48F8-1C4C-47B98B703C1A}"/>
              </a:ext>
            </a:extLst>
          </p:cNvPr>
          <p:cNvSpPr txBox="1"/>
          <p:nvPr/>
        </p:nvSpPr>
        <p:spPr>
          <a:xfrm>
            <a:off x="9286190" y="3333332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BDF4F0B-C967-64FB-B2BB-F41E5712142E}"/>
              </a:ext>
            </a:extLst>
          </p:cNvPr>
          <p:cNvSpPr txBox="1"/>
          <p:nvPr/>
        </p:nvSpPr>
        <p:spPr>
          <a:xfrm>
            <a:off x="10519202" y="975518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F082F36E-3669-2D3A-B850-756B0D606733}"/>
              </a:ext>
            </a:extLst>
          </p:cNvPr>
          <p:cNvSpPr/>
          <p:nvPr/>
        </p:nvSpPr>
        <p:spPr>
          <a:xfrm>
            <a:off x="10429354" y="929083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517B41E4-015A-0760-AEEF-6F3195084B61}"/>
              </a:ext>
            </a:extLst>
          </p:cNvPr>
          <p:cNvSpPr/>
          <p:nvPr/>
        </p:nvSpPr>
        <p:spPr>
          <a:xfrm>
            <a:off x="10429354" y="1065577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0A35FD22-9154-AA6B-B398-DC469D8997B3}"/>
              </a:ext>
            </a:extLst>
          </p:cNvPr>
          <p:cNvSpPr/>
          <p:nvPr/>
        </p:nvSpPr>
        <p:spPr>
          <a:xfrm>
            <a:off x="10429354" y="1200500"/>
            <a:ext cx="131348" cy="50824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3508BB7-270C-7406-5EBD-24B47595A577}"/>
              </a:ext>
            </a:extLst>
          </p:cNvPr>
          <p:cNvSpPr txBox="1"/>
          <p:nvPr/>
        </p:nvSpPr>
        <p:spPr>
          <a:xfrm>
            <a:off x="10512790" y="111939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4A404F8-E5A2-2CBA-FE93-7927EF2CA48F}"/>
              </a:ext>
            </a:extLst>
          </p:cNvPr>
          <p:cNvSpPr txBox="1"/>
          <p:nvPr/>
        </p:nvSpPr>
        <p:spPr>
          <a:xfrm>
            <a:off x="10531225" y="831006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pic>
        <p:nvPicPr>
          <p:cNvPr id="52" name="Content Placeholder 6">
            <a:extLst>
              <a:ext uri="{FF2B5EF4-FFF2-40B4-BE49-F238E27FC236}">
                <a16:creationId xmlns:a16="http://schemas.microsoft.com/office/drawing/2014/main" id="{1D608F73-5209-121B-AE74-F33D426BC8C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3" r="11317" b="7473"/>
          <a:stretch/>
        </p:blipFill>
        <p:spPr>
          <a:xfrm>
            <a:off x="8040914" y="1335210"/>
            <a:ext cx="3243624" cy="1986415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8734EC96-2AB5-AB13-E3E7-6D2255FF0E7A}"/>
              </a:ext>
            </a:extLst>
          </p:cNvPr>
          <p:cNvSpPr txBox="1"/>
          <p:nvPr/>
        </p:nvSpPr>
        <p:spPr>
          <a:xfrm rot="16200000">
            <a:off x="7769938" y="2342491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0868232-8D1F-FC09-CB90-AAEC1A6A3305}"/>
              </a:ext>
            </a:extLst>
          </p:cNvPr>
          <p:cNvSpPr txBox="1"/>
          <p:nvPr/>
        </p:nvSpPr>
        <p:spPr>
          <a:xfrm>
            <a:off x="1034535" y="636442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20DC875-9BEE-FD56-DF7C-153B498EA428}"/>
              </a:ext>
            </a:extLst>
          </p:cNvPr>
          <p:cNvSpPr txBox="1"/>
          <p:nvPr/>
        </p:nvSpPr>
        <p:spPr>
          <a:xfrm>
            <a:off x="2603191" y="6364428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97624C8-44C2-CDCE-83A4-170CEDD298EE}"/>
              </a:ext>
            </a:extLst>
          </p:cNvPr>
          <p:cNvSpPr txBox="1"/>
          <p:nvPr/>
        </p:nvSpPr>
        <p:spPr>
          <a:xfrm>
            <a:off x="1812591" y="6366562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2D8C05D-4560-333F-46D0-62A065EC362C}"/>
              </a:ext>
            </a:extLst>
          </p:cNvPr>
          <p:cNvSpPr txBox="1"/>
          <p:nvPr/>
        </p:nvSpPr>
        <p:spPr>
          <a:xfrm rot="16200000">
            <a:off x="332895" y="5294135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  <a:endParaRPr lang="en-US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B45DCEE-22B1-4513-BC8D-D2AC92E08E0C}"/>
              </a:ext>
            </a:extLst>
          </p:cNvPr>
          <p:cNvSpPr txBox="1"/>
          <p:nvPr/>
        </p:nvSpPr>
        <p:spPr>
          <a:xfrm>
            <a:off x="2992523" y="3794464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5B191FBC-49EC-E2BC-B800-ED1C405C50A8}"/>
              </a:ext>
            </a:extLst>
          </p:cNvPr>
          <p:cNvSpPr/>
          <p:nvPr/>
        </p:nvSpPr>
        <p:spPr>
          <a:xfrm>
            <a:off x="2902675" y="3748029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6E181A6D-A672-07CF-0855-3D0F6B31AB6E}"/>
              </a:ext>
            </a:extLst>
          </p:cNvPr>
          <p:cNvSpPr/>
          <p:nvPr/>
        </p:nvSpPr>
        <p:spPr>
          <a:xfrm>
            <a:off x="2902675" y="3884523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21A82942-E797-88D6-4740-B4463F3D4725}"/>
              </a:ext>
            </a:extLst>
          </p:cNvPr>
          <p:cNvSpPr/>
          <p:nvPr/>
        </p:nvSpPr>
        <p:spPr>
          <a:xfrm>
            <a:off x="2902675" y="4019446"/>
            <a:ext cx="131348" cy="50824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EAD800E-7E75-1E87-90DB-90FA84524AD8}"/>
              </a:ext>
            </a:extLst>
          </p:cNvPr>
          <p:cNvSpPr txBox="1"/>
          <p:nvPr/>
        </p:nvSpPr>
        <p:spPr>
          <a:xfrm>
            <a:off x="2986111" y="393834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B38F895-67BE-7961-6F19-3C33EF523F28}"/>
              </a:ext>
            </a:extLst>
          </p:cNvPr>
          <p:cNvSpPr txBox="1"/>
          <p:nvPr/>
        </p:nvSpPr>
        <p:spPr>
          <a:xfrm>
            <a:off x="3004546" y="3675276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pic>
        <p:nvPicPr>
          <p:cNvPr id="65" name="Content Placeholder 6">
            <a:extLst>
              <a:ext uri="{FF2B5EF4-FFF2-40B4-BE49-F238E27FC236}">
                <a16:creationId xmlns:a16="http://schemas.microsoft.com/office/drawing/2014/main" id="{EA89740A-CB07-E2E8-01B4-C85C8C6BF0D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0" r="13569" b="9356"/>
          <a:stretch/>
        </p:blipFill>
        <p:spPr>
          <a:xfrm>
            <a:off x="601662" y="4221242"/>
            <a:ext cx="3056965" cy="2113947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D4749786-BF13-E40B-23A4-C227501573E4}"/>
              </a:ext>
            </a:extLst>
          </p:cNvPr>
          <p:cNvSpPr txBox="1"/>
          <p:nvPr/>
        </p:nvSpPr>
        <p:spPr>
          <a:xfrm>
            <a:off x="4645977" y="640640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DC96D2C-8321-0F59-5CFB-B41BCF523AAB}"/>
              </a:ext>
            </a:extLst>
          </p:cNvPr>
          <p:cNvSpPr txBox="1"/>
          <p:nvPr/>
        </p:nvSpPr>
        <p:spPr>
          <a:xfrm>
            <a:off x="6214633" y="6406404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5A1E523-D786-2610-AA77-8E45162BD567}"/>
              </a:ext>
            </a:extLst>
          </p:cNvPr>
          <p:cNvSpPr txBox="1"/>
          <p:nvPr/>
        </p:nvSpPr>
        <p:spPr>
          <a:xfrm>
            <a:off x="5424033" y="6408538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AD607FD-06DE-F67E-D552-1B1F9DA2A924}"/>
              </a:ext>
            </a:extLst>
          </p:cNvPr>
          <p:cNvSpPr txBox="1"/>
          <p:nvPr/>
        </p:nvSpPr>
        <p:spPr>
          <a:xfrm>
            <a:off x="6603965" y="3836440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5C0E69DE-8A27-A001-3C68-1BC56562B223}"/>
              </a:ext>
            </a:extLst>
          </p:cNvPr>
          <p:cNvSpPr/>
          <p:nvPr/>
        </p:nvSpPr>
        <p:spPr>
          <a:xfrm>
            <a:off x="6514117" y="3790005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E38FFE20-9296-0E08-D3AE-12BBFA88C989}"/>
              </a:ext>
            </a:extLst>
          </p:cNvPr>
          <p:cNvSpPr/>
          <p:nvPr/>
        </p:nvSpPr>
        <p:spPr>
          <a:xfrm>
            <a:off x="6514117" y="3926499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90820C4E-977E-C2C7-DBE0-1DFCD0F98730}"/>
              </a:ext>
            </a:extLst>
          </p:cNvPr>
          <p:cNvSpPr/>
          <p:nvPr/>
        </p:nvSpPr>
        <p:spPr>
          <a:xfrm>
            <a:off x="6514117" y="4061422"/>
            <a:ext cx="131348" cy="50824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94FBF87-953C-F2F0-2A70-52C93E160600}"/>
              </a:ext>
            </a:extLst>
          </p:cNvPr>
          <p:cNvSpPr txBox="1"/>
          <p:nvPr/>
        </p:nvSpPr>
        <p:spPr>
          <a:xfrm>
            <a:off x="6597553" y="398031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A9D18AB-F7CB-C15B-F6F2-7AFB37F167C4}"/>
              </a:ext>
            </a:extLst>
          </p:cNvPr>
          <p:cNvSpPr txBox="1"/>
          <p:nvPr/>
        </p:nvSpPr>
        <p:spPr>
          <a:xfrm>
            <a:off x="6615988" y="3717252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F6F24CC-487A-8F26-4430-AA8C211A4B4F}"/>
              </a:ext>
            </a:extLst>
          </p:cNvPr>
          <p:cNvSpPr txBox="1"/>
          <p:nvPr/>
        </p:nvSpPr>
        <p:spPr>
          <a:xfrm rot="16200000">
            <a:off x="3862535" y="5243706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  <a:endParaRPr lang="en-US" dirty="0"/>
          </a:p>
        </p:txBody>
      </p:sp>
      <p:pic>
        <p:nvPicPr>
          <p:cNvPr id="77" name="Content Placeholder 6">
            <a:extLst>
              <a:ext uri="{FF2B5EF4-FFF2-40B4-BE49-F238E27FC236}">
                <a16:creationId xmlns:a16="http://schemas.microsoft.com/office/drawing/2014/main" id="{3F9B9112-B09A-3461-FE04-C80909CA86C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5" r="12977" b="6629"/>
          <a:stretch/>
        </p:blipFill>
        <p:spPr>
          <a:xfrm>
            <a:off x="4188219" y="4178916"/>
            <a:ext cx="3243624" cy="2177557"/>
          </a:xfrm>
          <a:prstGeom prst="rect">
            <a:avLst/>
          </a:prstGeom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0F6AD673-AE18-3425-6805-4D2474BD9861}"/>
              </a:ext>
            </a:extLst>
          </p:cNvPr>
          <p:cNvSpPr txBox="1"/>
          <p:nvPr/>
        </p:nvSpPr>
        <p:spPr>
          <a:xfrm>
            <a:off x="8493199" y="637961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F57B452-657A-2D81-51C6-8D5DDB5BF58A}"/>
              </a:ext>
            </a:extLst>
          </p:cNvPr>
          <p:cNvSpPr txBox="1"/>
          <p:nvPr/>
        </p:nvSpPr>
        <p:spPr>
          <a:xfrm>
            <a:off x="10061855" y="6379613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B48994E-B4EC-CC11-B47D-C182CC3FF911}"/>
              </a:ext>
            </a:extLst>
          </p:cNvPr>
          <p:cNvSpPr txBox="1"/>
          <p:nvPr/>
        </p:nvSpPr>
        <p:spPr>
          <a:xfrm>
            <a:off x="9271255" y="6381747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8B26E7B-5C75-F5C2-D67C-87A6D0FE762F}"/>
              </a:ext>
            </a:extLst>
          </p:cNvPr>
          <p:cNvSpPr txBox="1"/>
          <p:nvPr/>
        </p:nvSpPr>
        <p:spPr>
          <a:xfrm rot="16200000">
            <a:off x="7569544" y="5309320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  <a:endParaRPr lang="en-US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BC8BEA5-7AE4-A97D-0E0E-647B1CEA77B7}"/>
              </a:ext>
            </a:extLst>
          </p:cNvPr>
          <p:cNvSpPr txBox="1"/>
          <p:nvPr/>
        </p:nvSpPr>
        <p:spPr>
          <a:xfrm>
            <a:off x="10451187" y="3809649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49C26621-FEF2-7BF5-A914-51DC25ED5317}"/>
              </a:ext>
            </a:extLst>
          </p:cNvPr>
          <p:cNvSpPr/>
          <p:nvPr/>
        </p:nvSpPr>
        <p:spPr>
          <a:xfrm>
            <a:off x="10361339" y="3763214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53446CA9-358A-E520-4AD2-3A9E447E8E56}"/>
              </a:ext>
            </a:extLst>
          </p:cNvPr>
          <p:cNvSpPr/>
          <p:nvPr/>
        </p:nvSpPr>
        <p:spPr>
          <a:xfrm>
            <a:off x="10361339" y="3899708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298BB989-16CD-95AD-FA78-22B263CECE4B}"/>
              </a:ext>
            </a:extLst>
          </p:cNvPr>
          <p:cNvSpPr/>
          <p:nvPr/>
        </p:nvSpPr>
        <p:spPr>
          <a:xfrm>
            <a:off x="10361339" y="4034631"/>
            <a:ext cx="131348" cy="50824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B1467FA-78D3-9E86-DD82-EBC865B5CE3C}"/>
              </a:ext>
            </a:extLst>
          </p:cNvPr>
          <p:cNvSpPr txBox="1"/>
          <p:nvPr/>
        </p:nvSpPr>
        <p:spPr>
          <a:xfrm>
            <a:off x="10444775" y="395352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02BF826-BFA1-4805-C5DB-5DBC7C488BA7}"/>
              </a:ext>
            </a:extLst>
          </p:cNvPr>
          <p:cNvSpPr txBox="1"/>
          <p:nvPr/>
        </p:nvSpPr>
        <p:spPr>
          <a:xfrm>
            <a:off x="10447981" y="3663610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pic>
        <p:nvPicPr>
          <p:cNvPr id="89" name="Content Placeholder 6">
            <a:extLst>
              <a:ext uri="{FF2B5EF4-FFF2-40B4-BE49-F238E27FC236}">
                <a16:creationId xmlns:a16="http://schemas.microsoft.com/office/drawing/2014/main" id="{3F3F98CA-18D0-77FB-6CB4-31A5419A9DE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3" r="13003" b="6629"/>
          <a:stretch/>
        </p:blipFill>
        <p:spPr>
          <a:xfrm>
            <a:off x="8049021" y="4167584"/>
            <a:ext cx="3180453" cy="2177557"/>
          </a:xfrm>
          <a:prstGeom prst="rect">
            <a:avLst/>
          </a:prstGeom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CC15FCF0-F763-30CB-0876-333091C052BC}"/>
              </a:ext>
            </a:extLst>
          </p:cNvPr>
          <p:cNvSpPr txBox="1"/>
          <p:nvPr/>
        </p:nvSpPr>
        <p:spPr>
          <a:xfrm>
            <a:off x="2732136" y="726056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Beta Blockers</a:t>
            </a:r>
            <a:endParaRPr lang="en-US" sz="9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F0AF7D9-A618-0A35-7F92-915D5D529F0D}"/>
              </a:ext>
            </a:extLst>
          </p:cNvPr>
          <p:cNvSpPr txBox="1"/>
          <p:nvPr/>
        </p:nvSpPr>
        <p:spPr>
          <a:xfrm>
            <a:off x="10280023" y="726056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Beta Blockers</a:t>
            </a:r>
            <a:endParaRPr lang="en-US" sz="9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735377B-5458-BBAD-06D9-1C37FE6F0296}"/>
              </a:ext>
            </a:extLst>
          </p:cNvPr>
          <p:cNvSpPr txBox="1"/>
          <p:nvPr/>
        </p:nvSpPr>
        <p:spPr>
          <a:xfrm>
            <a:off x="6499128" y="716097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Beta Blockers</a:t>
            </a:r>
            <a:endParaRPr lang="en-US" sz="9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46889F0-CAF8-8DDA-879E-6649378CACDC}"/>
              </a:ext>
            </a:extLst>
          </p:cNvPr>
          <p:cNvSpPr txBox="1"/>
          <p:nvPr/>
        </p:nvSpPr>
        <p:spPr>
          <a:xfrm>
            <a:off x="10254706" y="3571226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Beta Blockers</a:t>
            </a:r>
            <a:endParaRPr lang="en-US" sz="9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1095527-060C-A92E-57FD-2673E6BD1868}"/>
              </a:ext>
            </a:extLst>
          </p:cNvPr>
          <p:cNvSpPr txBox="1"/>
          <p:nvPr/>
        </p:nvSpPr>
        <p:spPr>
          <a:xfrm>
            <a:off x="6388338" y="3580818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Beta Blockers</a:t>
            </a:r>
            <a:endParaRPr lang="en-US" sz="9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AAE7546-FDCD-2529-D441-AE4F2031A0F6}"/>
              </a:ext>
            </a:extLst>
          </p:cNvPr>
          <p:cNvSpPr txBox="1"/>
          <p:nvPr/>
        </p:nvSpPr>
        <p:spPr>
          <a:xfrm>
            <a:off x="2799283" y="3560016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Beta Blockers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369907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Macintosh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lio Vinciguera</dc:creator>
  <cp:lastModifiedBy>Manlio Vinciguera</cp:lastModifiedBy>
  <cp:revision>1</cp:revision>
  <dcterms:created xsi:type="dcterms:W3CDTF">2025-11-02T17:48:10Z</dcterms:created>
  <dcterms:modified xsi:type="dcterms:W3CDTF">2025-11-02T17:48:23Z</dcterms:modified>
</cp:coreProperties>
</file>